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sldIdLst>
    <p:sldId id="263" r:id="rId2"/>
    <p:sldId id="262" r:id="rId3"/>
    <p:sldId id="264" r:id="rId4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7073" autoAdjust="0"/>
    <p:restoredTop sz="94660"/>
  </p:normalViewPr>
  <p:slideViewPr>
    <p:cSldViewPr snapToGrid="0">
      <p:cViewPr varScale="1">
        <p:scale>
          <a:sx n="75" d="100"/>
          <a:sy n="75" d="100"/>
        </p:scale>
        <p:origin x="-1440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1549682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1835380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3620923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4071880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570390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3682299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3640546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4212728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329610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280100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3626456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8C72-403A-47B2-A694-100EFF204E07}" type="datetimeFigureOut">
              <a:rPr lang="he-IL" smtClean="0"/>
              <a:pPr/>
              <a:t>ט"ז/תשרי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EF9D6-8C9D-49D9-AD02-14B76660741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xmlns="" val="4114330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microsoft.com/office/2007/relationships/hdphoto" Target="../media/hdphoto2.wdp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084A5078-D101-C649-B046-29FD4DFD10BF}"/>
              </a:ext>
            </a:extLst>
          </p:cNvPr>
          <p:cNvGrpSpPr/>
          <p:nvPr/>
        </p:nvGrpSpPr>
        <p:grpSpPr>
          <a:xfrm>
            <a:off x="-21099" y="800795"/>
            <a:ext cx="6542540" cy="2726184"/>
            <a:chOff x="1809087" y="3767685"/>
            <a:chExt cx="6542540" cy="2793105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E987E9B8-AA77-724C-9036-88B7D6EDC2A7}"/>
                </a:ext>
              </a:extLst>
            </p:cNvPr>
            <p:cNvSpPr txBox="1"/>
            <p:nvPr/>
          </p:nvSpPr>
          <p:spPr>
            <a:xfrm>
              <a:off x="2024532" y="4338749"/>
              <a:ext cx="400110" cy="46991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</a:rPr>
                <a:t>GFP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629C7F8A-A5FB-9848-9C8B-111C8733881F}"/>
                </a:ext>
              </a:extLst>
            </p:cNvPr>
            <p:cNvSpPr txBox="1"/>
            <p:nvPr/>
          </p:nvSpPr>
          <p:spPr>
            <a:xfrm>
              <a:off x="7549013" y="3881924"/>
              <a:ext cx="488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</a:rPr>
                <a:t> 34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FF772740-01BF-EE44-AFDF-01B4825BB963}"/>
                </a:ext>
              </a:extLst>
            </p:cNvPr>
            <p:cNvSpPr txBox="1"/>
            <p:nvPr/>
          </p:nvSpPr>
          <p:spPr>
            <a:xfrm>
              <a:off x="6549360" y="3881924"/>
              <a:ext cx="488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</a:rPr>
                <a:t> 38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1197619F-15B9-8F4F-A08E-44BEBF1B2332}"/>
                </a:ext>
              </a:extLst>
            </p:cNvPr>
            <p:cNvSpPr txBox="1"/>
            <p:nvPr/>
          </p:nvSpPr>
          <p:spPr>
            <a:xfrm>
              <a:off x="5734608" y="3869763"/>
              <a:ext cx="488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</a:rPr>
                <a:t> 39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2ED7EBFB-8A3F-4642-BB51-0A25A886ACEF}"/>
                </a:ext>
              </a:extLst>
            </p:cNvPr>
            <p:cNvSpPr txBox="1"/>
            <p:nvPr/>
          </p:nvSpPr>
          <p:spPr>
            <a:xfrm>
              <a:off x="4560768" y="3858610"/>
              <a:ext cx="488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</a:rPr>
                <a:t> 4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A24AB361-BD66-EA44-AC00-111263981B12}"/>
                </a:ext>
              </a:extLst>
            </p:cNvPr>
            <p:cNvSpPr txBox="1"/>
            <p:nvPr/>
          </p:nvSpPr>
          <p:spPr>
            <a:xfrm>
              <a:off x="3678452" y="3858611"/>
              <a:ext cx="488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</a:rPr>
                <a:t> 4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5A26EB9C-DDD7-1140-9A57-B940E690F188}"/>
                </a:ext>
              </a:extLst>
            </p:cNvPr>
            <p:cNvSpPr txBox="1"/>
            <p:nvPr/>
          </p:nvSpPr>
          <p:spPr>
            <a:xfrm>
              <a:off x="2024532" y="3863733"/>
              <a:ext cx="13975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</a:rPr>
                <a:t>Control (-)</a:t>
              </a:r>
            </a:p>
          </p:txBody>
        </p:sp>
        <p:pic>
          <p:nvPicPr>
            <p:cNvPr id="12" name="תמונה 8">
              <a:extLst>
                <a:ext uri="{FF2B5EF4-FFF2-40B4-BE49-F238E27FC236}">
                  <a16:creationId xmlns:a16="http://schemas.microsoft.com/office/drawing/2014/main" xmlns="" id="{D0A5EADE-3691-5941-ACFB-7B3361E997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 xmlns="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6239" t="2311" r="43193" b="3365"/>
            <a:stretch/>
          </p:blipFill>
          <p:spPr>
            <a:xfrm rot="16200000" flipV="1">
              <a:off x="4298212" y="2222884"/>
              <a:ext cx="2179845" cy="5926985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D96E3501-0A8E-A54F-9570-B14EB5F96CD6}"/>
                </a:ext>
              </a:extLst>
            </p:cNvPr>
            <p:cNvSpPr txBox="1"/>
            <p:nvPr/>
          </p:nvSpPr>
          <p:spPr>
            <a:xfrm>
              <a:off x="1809087" y="5006683"/>
              <a:ext cx="615553" cy="155410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 rtl="0"/>
              <a:r>
                <a:rPr lang="el-GR" sz="1400" dirty="0">
                  <a:latin typeface="Arial" panose="020B0604020202020204" pitchFamily="34" charset="0"/>
                </a:rPr>
                <a:t>Δ</a:t>
              </a:r>
              <a:r>
                <a:rPr lang="en-US" sz="1400" dirty="0">
                  <a:latin typeface="Arial" panose="020B0604020202020204" pitchFamily="34" charset="0"/>
                </a:rPr>
                <a:t>33 </a:t>
              </a:r>
            </a:p>
            <a:p>
              <a:pPr algn="ctr" rtl="0"/>
              <a:r>
                <a:rPr lang="el-GR" sz="1400" dirty="0">
                  <a:latin typeface="Arial" panose="020B0604020202020204" pitchFamily="34" charset="0"/>
                </a:rPr>
                <a:t>β</a:t>
              </a:r>
              <a:r>
                <a:rPr lang="en-US" sz="1400" dirty="0">
                  <a:latin typeface="Arial" panose="020B0604020202020204" pitchFamily="34" charset="0"/>
                </a:rPr>
                <a:t>-catenin GFP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xmlns="" id="{CDCD9BFB-9AC7-1040-BDBA-AB615B4B6761}"/>
                </a:ext>
              </a:extLst>
            </p:cNvPr>
            <p:cNvCxnSpPr/>
            <p:nvPr/>
          </p:nvCxnSpPr>
          <p:spPr>
            <a:xfrm>
              <a:off x="3885907" y="3767685"/>
              <a:ext cx="40019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8D3A639A-60B2-E344-818E-6654A9CE2D17}"/>
              </a:ext>
            </a:extLst>
          </p:cNvPr>
          <p:cNvSpPr txBox="1"/>
          <p:nvPr/>
        </p:nvSpPr>
        <p:spPr>
          <a:xfrm>
            <a:off x="3353257" y="467135"/>
            <a:ext cx="8899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</a:rPr>
              <a:t>Clone #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A575810D-56FB-4940-96CD-03DAA4A917F8}"/>
              </a:ext>
            </a:extLst>
          </p:cNvPr>
          <p:cNvSpPr/>
          <p:nvPr/>
        </p:nvSpPr>
        <p:spPr>
          <a:xfrm>
            <a:off x="1714498" y="1124791"/>
            <a:ext cx="864158" cy="2130973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914400" rtl="0" eaLnBrk="1" latinLnBrk="0" hangingPunct="1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67AB9162-B497-1743-993D-645E1F002E6D}"/>
              </a:ext>
            </a:extLst>
          </p:cNvPr>
          <p:cNvSpPr txBox="1"/>
          <p:nvPr/>
        </p:nvSpPr>
        <p:spPr>
          <a:xfrm>
            <a:off x="-29810" y="126829"/>
            <a:ext cx="2760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he-IL" dirty="0">
                <a:latin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</a:rPr>
              <a:t>Supplementary Figure 1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2053" y="714600"/>
            <a:ext cx="41549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קבוצה 2">
            <a:extLst>
              <a:ext uri="{FF2B5EF4-FFF2-40B4-BE49-F238E27FC236}">
                <a16:creationId xmlns:a16="http://schemas.microsoft.com/office/drawing/2014/main" xmlns="" id="{216E32A1-D90F-4A6B-AF1F-E40B01C6FD29}"/>
              </a:ext>
            </a:extLst>
          </p:cNvPr>
          <p:cNvGrpSpPr/>
          <p:nvPr/>
        </p:nvGrpSpPr>
        <p:grpSpPr>
          <a:xfrm>
            <a:off x="108045" y="3751187"/>
            <a:ext cx="4077064" cy="2627835"/>
            <a:chOff x="194346" y="3769765"/>
            <a:chExt cx="4077064" cy="2627835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645" t="50118" r="60901" b="23694"/>
            <a:stretch/>
          </p:blipFill>
          <p:spPr>
            <a:xfrm>
              <a:off x="1425249" y="5163450"/>
              <a:ext cx="922634" cy="897924"/>
            </a:xfrm>
            <a:prstGeom prst="ellipse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4564" t="19125" r="61982" b="54687"/>
            <a:stretch/>
          </p:blipFill>
          <p:spPr>
            <a:xfrm>
              <a:off x="1425248" y="4232064"/>
              <a:ext cx="922634" cy="897924"/>
            </a:xfrm>
            <a:prstGeom prst="ellipse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1141" t="19605" r="45405" b="54207"/>
            <a:stretch/>
          </p:blipFill>
          <p:spPr>
            <a:xfrm>
              <a:off x="2389073" y="4232064"/>
              <a:ext cx="922634" cy="897924"/>
            </a:xfrm>
            <a:prstGeom prst="ellipse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1141" t="51319" r="45405" b="22493"/>
            <a:stretch/>
          </p:blipFill>
          <p:spPr>
            <a:xfrm>
              <a:off x="2389073" y="5163450"/>
              <a:ext cx="922634" cy="897924"/>
            </a:xfrm>
            <a:prstGeom prst="ellipse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6637" t="19845" r="29909" b="53967"/>
            <a:stretch/>
          </p:blipFill>
          <p:spPr>
            <a:xfrm>
              <a:off x="3344659" y="4232064"/>
              <a:ext cx="922634" cy="897924"/>
            </a:xfrm>
            <a:prstGeom prst="ellipse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7598" t="50598" r="28948" b="23214"/>
            <a:stretch/>
          </p:blipFill>
          <p:spPr>
            <a:xfrm>
              <a:off x="3348776" y="5163450"/>
              <a:ext cx="922634" cy="897924"/>
            </a:xfrm>
            <a:prstGeom prst="ellipse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3537773" y="3966233"/>
              <a:ext cx="514885" cy="33855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/>
              <a:r>
                <a:rPr lang="en-US" sz="1600" dirty="0"/>
                <a:t>#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he-IL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 rot="20203660">
              <a:off x="1420839" y="3832963"/>
              <a:ext cx="128913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TCF-</a:t>
              </a:r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Hygro</a:t>
              </a:r>
              <a:r>
                <a:rPr lang="en-US" sz="16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1600" dirty="0"/>
                <a:t> </a:t>
              </a:r>
            </a:p>
          </p:txBody>
        </p:sp>
        <p:sp>
          <p:nvSpPr>
            <p:cNvPr id="22" name="Rectangle 21"/>
            <p:cNvSpPr/>
            <p:nvPr/>
          </p:nvSpPr>
          <p:spPr>
            <a:xfrm rot="20203660">
              <a:off x="2390914" y="3769765"/>
              <a:ext cx="141417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mTCF-Hygro</a:t>
              </a:r>
              <a:r>
                <a:rPr lang="en-US" sz="16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endParaRPr lang="en-US" sz="16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94346" y="3950844"/>
              <a:ext cx="415498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he-IL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4">
              <a:extLst>
                <a:ext uri="{FF2B5EF4-FFF2-40B4-BE49-F238E27FC236}">
                  <a16:creationId xmlns:a16="http://schemas.microsoft.com/office/drawing/2014/main" xmlns="" id="{1D95A29A-9FDA-4A82-A37E-06F513DC8494}"/>
                </a:ext>
              </a:extLst>
            </p:cNvPr>
            <p:cNvSpPr txBox="1"/>
            <p:nvPr/>
          </p:nvSpPr>
          <p:spPr>
            <a:xfrm>
              <a:off x="1011607" y="4228798"/>
              <a:ext cx="400110" cy="45865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</a:rPr>
                <a:t>GFP</a:t>
              </a:r>
            </a:p>
          </p:txBody>
        </p:sp>
        <p:sp>
          <p:nvSpPr>
            <p:cNvPr id="34" name="TextBox 12">
              <a:extLst>
                <a:ext uri="{FF2B5EF4-FFF2-40B4-BE49-F238E27FC236}">
                  <a16:creationId xmlns:a16="http://schemas.microsoft.com/office/drawing/2014/main" xmlns="" id="{5625E0DF-24C7-4EF5-8EFC-46B21692F1DA}"/>
                </a:ext>
              </a:extLst>
            </p:cNvPr>
            <p:cNvSpPr txBox="1"/>
            <p:nvPr/>
          </p:nvSpPr>
          <p:spPr>
            <a:xfrm>
              <a:off x="796162" y="4880728"/>
              <a:ext cx="615553" cy="151687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 rtl="0"/>
              <a:r>
                <a:rPr lang="el-GR" sz="1400" dirty="0">
                  <a:latin typeface="Arial" panose="020B0604020202020204" pitchFamily="34" charset="0"/>
                </a:rPr>
                <a:t>Δ</a:t>
              </a:r>
              <a:r>
                <a:rPr lang="en-US" sz="1400" dirty="0">
                  <a:latin typeface="Arial" panose="020B0604020202020204" pitchFamily="34" charset="0"/>
                </a:rPr>
                <a:t>33 </a:t>
              </a:r>
            </a:p>
            <a:p>
              <a:pPr algn="ctr" rtl="0"/>
              <a:r>
                <a:rPr lang="el-GR" sz="1400" dirty="0">
                  <a:latin typeface="Arial" panose="020B0604020202020204" pitchFamily="34" charset="0"/>
                </a:rPr>
                <a:t>β</a:t>
              </a:r>
              <a:r>
                <a:rPr lang="en-US" sz="1400" dirty="0">
                  <a:latin typeface="Arial" panose="020B0604020202020204" pitchFamily="34" charset="0"/>
                </a:rPr>
                <a:t>-catenin GF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3650845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67AB9162-B497-1743-993D-645E1F002E6D}"/>
              </a:ext>
            </a:extLst>
          </p:cNvPr>
          <p:cNvSpPr txBox="1"/>
          <p:nvPr/>
        </p:nvSpPr>
        <p:spPr>
          <a:xfrm>
            <a:off x="-8286" y="0"/>
            <a:ext cx="3908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he-IL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35" name="תמונה 5">
            <a:extLst>
              <a:ext uri="{FF2B5EF4-FFF2-40B4-BE49-F238E27FC236}">
                <a16:creationId xmlns:a16="http://schemas.microsoft.com/office/drawing/2014/main" xmlns="" id="{D8CFFE18-58DA-2F4E-8500-FCFD749887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3727" t="49938" r="46144" b="46383"/>
          <a:stretch/>
        </p:blipFill>
        <p:spPr>
          <a:xfrm flipH="1">
            <a:off x="1359512" y="2325213"/>
            <a:ext cx="2366199" cy="431120"/>
          </a:xfrm>
          <a:prstGeom prst="rect">
            <a:avLst/>
          </a:prstGeom>
        </p:spPr>
      </p:pic>
      <p:pic>
        <p:nvPicPr>
          <p:cNvPr id="36" name="תמונה 7">
            <a:extLst>
              <a:ext uri="{FF2B5EF4-FFF2-40B4-BE49-F238E27FC236}">
                <a16:creationId xmlns:a16="http://schemas.microsoft.com/office/drawing/2014/main" xmlns="" id="{C14981BF-8E4B-6345-88F0-7ACC8A64A38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4944" b="12427"/>
          <a:stretch/>
        </p:blipFill>
        <p:spPr>
          <a:xfrm flipH="1">
            <a:off x="1359580" y="1884055"/>
            <a:ext cx="2367734" cy="401627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3D38385D-BED7-904A-AE70-355805EF4512}"/>
              </a:ext>
            </a:extLst>
          </p:cNvPr>
          <p:cNvSpPr txBox="1"/>
          <p:nvPr/>
        </p:nvSpPr>
        <p:spPr>
          <a:xfrm>
            <a:off x="646296" y="2336705"/>
            <a:ext cx="7751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A042DD38-741B-304D-A592-F9C59CC7FEFA}"/>
              </a:ext>
            </a:extLst>
          </p:cNvPr>
          <p:cNvSpPr txBox="1"/>
          <p:nvPr/>
        </p:nvSpPr>
        <p:spPr>
          <a:xfrm>
            <a:off x="646296" y="1896488"/>
            <a:ext cx="7751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HX29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7DBCC2B1-08E9-9F40-8D6C-EDBF8AEA5497}"/>
              </a:ext>
            </a:extLst>
          </p:cNvPr>
          <p:cNvSpPr txBox="1"/>
          <p:nvPr/>
        </p:nvSpPr>
        <p:spPr>
          <a:xfrm rot="19150113">
            <a:off x="1805306" y="1296115"/>
            <a:ext cx="1280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HX29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Active#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4B9014D4-E949-4E40-A35F-927893B3AA6A}"/>
              </a:ext>
            </a:extLst>
          </p:cNvPr>
          <p:cNvSpPr txBox="1"/>
          <p:nvPr/>
        </p:nvSpPr>
        <p:spPr>
          <a:xfrm rot="19150113">
            <a:off x="2416232" y="1310372"/>
            <a:ext cx="12521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HX29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Active#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BD78C5D4-90E7-504D-9153-3946D5FC942F}"/>
              </a:ext>
            </a:extLst>
          </p:cNvPr>
          <p:cNvSpPr txBox="1"/>
          <p:nvPr/>
        </p:nvSpPr>
        <p:spPr>
          <a:xfrm rot="19150113">
            <a:off x="2998788" y="1296115"/>
            <a:ext cx="12357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HX29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Active#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745DDAE7-24AE-804B-A96F-5312AF6689A2}"/>
              </a:ext>
            </a:extLst>
          </p:cNvPr>
          <p:cNvSpPr txBox="1"/>
          <p:nvPr/>
        </p:nvSpPr>
        <p:spPr>
          <a:xfrm rot="19150113">
            <a:off x="1265080" y="1448517"/>
            <a:ext cx="962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NT1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023F626A-46A8-2C4A-A2CC-E41BFF91B8F9}"/>
              </a:ext>
            </a:extLst>
          </p:cNvPr>
          <p:cNvSpPr txBox="1"/>
          <p:nvPr/>
        </p:nvSpPr>
        <p:spPr>
          <a:xfrm>
            <a:off x="3532150" y="1638781"/>
            <a:ext cx="4787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6996F5FB-28C7-A740-85B8-51E64CFF3BFD}"/>
              </a:ext>
            </a:extLst>
          </p:cNvPr>
          <p:cNvSpPr txBox="1"/>
          <p:nvPr/>
        </p:nvSpPr>
        <p:spPr>
          <a:xfrm>
            <a:off x="3645340" y="1934698"/>
            <a:ext cx="5394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87786AA1-1ABA-8541-AF2D-73658A01D735}"/>
              </a:ext>
            </a:extLst>
          </p:cNvPr>
          <p:cNvSpPr txBox="1"/>
          <p:nvPr/>
        </p:nvSpPr>
        <p:spPr>
          <a:xfrm>
            <a:off x="3708897" y="2393827"/>
            <a:ext cx="5215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CBE7977D-EED7-4E4C-95A3-7969014F24D1}"/>
              </a:ext>
            </a:extLst>
          </p:cNvPr>
          <p:cNvGrpSpPr/>
          <p:nvPr/>
        </p:nvGrpSpPr>
        <p:grpSpPr>
          <a:xfrm>
            <a:off x="1190994" y="4902236"/>
            <a:ext cx="2310511" cy="1673959"/>
            <a:chOff x="1611704" y="7285670"/>
            <a:chExt cx="2310511" cy="1673959"/>
          </a:xfrm>
        </p:grpSpPr>
        <p:pic>
          <p:nvPicPr>
            <p:cNvPr id="52" name="תמונה 65">
              <a:extLst>
                <a:ext uri="{FF2B5EF4-FFF2-40B4-BE49-F238E27FC236}">
                  <a16:creationId xmlns:a16="http://schemas.microsoft.com/office/drawing/2014/main" xmlns="" id="{AFF40D5F-FBB9-8A45-8F16-ECDEE5A460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 xmlns="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2039" t="32620" r="36078" b="57268"/>
            <a:stretch/>
          </p:blipFill>
          <p:spPr>
            <a:xfrm flipH="1">
              <a:off x="2542613" y="7581616"/>
              <a:ext cx="1021827" cy="826979"/>
            </a:xfrm>
            <a:prstGeom prst="rect">
              <a:avLst/>
            </a:prstGeom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7293A8CB-680A-DC41-9CDA-8A0D8B954384}"/>
                </a:ext>
              </a:extLst>
            </p:cNvPr>
            <p:cNvSpPr txBox="1"/>
            <p:nvPr/>
          </p:nvSpPr>
          <p:spPr>
            <a:xfrm>
              <a:off x="3142178" y="7674464"/>
              <a:ext cx="7800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08D5DDF4-018C-A944-BB87-992CBF6D4A11}"/>
                </a:ext>
              </a:extLst>
            </p:cNvPr>
            <p:cNvSpPr txBox="1"/>
            <p:nvPr/>
          </p:nvSpPr>
          <p:spPr>
            <a:xfrm>
              <a:off x="3369269" y="8126401"/>
              <a:ext cx="5399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xmlns="" id="{B31231CF-E273-7A4B-9392-D7D0AE57EF00}"/>
                </a:ext>
              </a:extLst>
            </p:cNvPr>
            <p:cNvSpPr txBox="1"/>
            <p:nvPr/>
          </p:nvSpPr>
          <p:spPr>
            <a:xfrm>
              <a:off x="1794780" y="7604750"/>
              <a:ext cx="912881" cy="600164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ctive </a:t>
              </a:r>
            </a:p>
            <a:p>
              <a:pPr algn="ctr"/>
              <a:r>
                <a:rPr lang="en-US" sz="11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-catenin</a:t>
              </a:r>
            </a:p>
            <a:p>
              <a:pPr algn="ctr"/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437AD9F7-9B4F-F742-B37A-CED091D61225}"/>
                </a:ext>
              </a:extLst>
            </p:cNvPr>
            <p:cNvSpPr txBox="1"/>
            <p:nvPr/>
          </p:nvSpPr>
          <p:spPr>
            <a:xfrm>
              <a:off x="1622003" y="8148614"/>
              <a:ext cx="973394" cy="261610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7" name="תמונה 70">
              <a:extLst>
                <a:ext uri="{FF2B5EF4-FFF2-40B4-BE49-F238E27FC236}">
                  <a16:creationId xmlns:a16="http://schemas.microsoft.com/office/drawing/2014/main" xmlns="" id="{F95C1CFC-5161-6044-863A-688CDEC91C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3675" t="2" r="27774" b="43767"/>
            <a:stretch/>
          </p:blipFill>
          <p:spPr>
            <a:xfrm flipH="1">
              <a:off x="2542612" y="8487089"/>
              <a:ext cx="1021828" cy="397369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xmlns="" id="{8B92626B-909B-A045-A1FD-CC630008AA73}"/>
                </a:ext>
              </a:extLst>
            </p:cNvPr>
            <p:cNvSpPr txBox="1"/>
            <p:nvPr/>
          </p:nvSpPr>
          <p:spPr>
            <a:xfrm>
              <a:off x="3131341" y="8713408"/>
              <a:ext cx="7374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4F068A77-0344-6C46-8538-50F14ACF51F8}"/>
                </a:ext>
              </a:extLst>
            </p:cNvPr>
            <p:cNvSpPr txBox="1"/>
            <p:nvPr/>
          </p:nvSpPr>
          <p:spPr>
            <a:xfrm>
              <a:off x="1611704" y="8588982"/>
              <a:ext cx="949701" cy="261610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yclin-D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A0737CFA-7570-A34D-98A6-43672F69A227}"/>
                </a:ext>
              </a:extLst>
            </p:cNvPr>
            <p:cNvSpPr txBox="1"/>
            <p:nvPr/>
          </p:nvSpPr>
          <p:spPr>
            <a:xfrm rot="18905249">
              <a:off x="2829174" y="7285670"/>
              <a:ext cx="950203" cy="2870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Wnt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3A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6959C3B1-CA7B-2B4D-8C3F-4602CA0C1973}"/>
                </a:ext>
              </a:extLst>
            </p:cNvPr>
            <p:cNvSpPr txBox="1"/>
            <p:nvPr/>
          </p:nvSpPr>
          <p:spPr>
            <a:xfrm rot="18905249">
              <a:off x="2179183" y="7348752"/>
              <a:ext cx="1163905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-media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02E1AB49-C168-124D-B037-456149CA2680}"/>
                </a:ext>
              </a:extLst>
            </p:cNvPr>
            <p:cNvSpPr txBox="1"/>
            <p:nvPr/>
          </p:nvSpPr>
          <p:spPr>
            <a:xfrm>
              <a:off x="2918292" y="7441158"/>
              <a:ext cx="9941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BAF56AAE-AF59-D144-8F5D-D8C3C8CEC71B}"/>
              </a:ext>
            </a:extLst>
          </p:cNvPr>
          <p:cNvSpPr txBox="1"/>
          <p:nvPr/>
        </p:nvSpPr>
        <p:spPr>
          <a:xfrm>
            <a:off x="0" y="4245638"/>
            <a:ext cx="3908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he-IL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xmlns="" val="23333321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1">
            <a:extLst>
              <a:ext uri="{FF2B5EF4-FFF2-40B4-BE49-F238E27FC236}">
                <a16:creationId xmlns:a16="http://schemas.microsoft.com/office/drawing/2014/main" xmlns="" id="{413971AB-6D8D-4F4E-AC09-4F7A31DDB66D}"/>
              </a:ext>
            </a:extLst>
          </p:cNvPr>
          <p:cNvSpPr txBox="1"/>
          <p:nvPr/>
        </p:nvSpPr>
        <p:spPr>
          <a:xfrm>
            <a:off x="0" y="116984"/>
            <a:ext cx="3908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he-IL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pic>
        <p:nvPicPr>
          <p:cNvPr id="5" name="תמונה 4" descr="תמונה שמכילה טבע&#10;&#10;התיאור נוצר באופן אוטומטי">
            <a:extLst>
              <a:ext uri="{FF2B5EF4-FFF2-40B4-BE49-F238E27FC236}">
                <a16:creationId xmlns:a16="http://schemas.microsoft.com/office/drawing/2014/main" xmlns="" id="{F591D5A6-61EA-48BD-A09E-75C364654C5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631275" y="1465580"/>
            <a:ext cx="2150726" cy="1613045"/>
          </a:xfrm>
          <a:prstGeom prst="rect">
            <a:avLst/>
          </a:prstGeom>
        </p:spPr>
      </p:pic>
      <p:pic>
        <p:nvPicPr>
          <p:cNvPr id="6" name="תמונה 5" descr="תמונה שמכילה טבע, גשם&#10;&#10;התיאור נוצר באופן אוטומטי">
            <a:extLst>
              <a:ext uri="{FF2B5EF4-FFF2-40B4-BE49-F238E27FC236}">
                <a16:creationId xmlns:a16="http://schemas.microsoft.com/office/drawing/2014/main" xmlns="" id="{F0DC41C2-0AD2-46F0-8191-D8DC458E669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631275" y="5040976"/>
            <a:ext cx="2150726" cy="1613045"/>
          </a:xfrm>
          <a:prstGeom prst="rect">
            <a:avLst/>
          </a:prstGeom>
        </p:spPr>
      </p:pic>
      <p:pic>
        <p:nvPicPr>
          <p:cNvPr id="8" name="תמונה 7" descr="תמונה שמכילה טבע, גשם&#10;&#10;התיאור נוצר באופן אוטומטי">
            <a:extLst>
              <a:ext uri="{FF2B5EF4-FFF2-40B4-BE49-F238E27FC236}">
                <a16:creationId xmlns:a16="http://schemas.microsoft.com/office/drawing/2014/main" xmlns="" id="{51126502-311F-437F-BA42-88445F38C05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631275" y="3251979"/>
            <a:ext cx="2150726" cy="1613045"/>
          </a:xfrm>
          <a:prstGeom prst="rect">
            <a:avLst/>
          </a:prstGeom>
        </p:spPr>
      </p:pic>
      <p:pic>
        <p:nvPicPr>
          <p:cNvPr id="9" name="תמונה 8" descr="תמונה שמכילה טבע, גשם&#10;&#10;התיאור נוצר באופן אוטומטי">
            <a:extLst>
              <a:ext uri="{FF2B5EF4-FFF2-40B4-BE49-F238E27FC236}">
                <a16:creationId xmlns:a16="http://schemas.microsoft.com/office/drawing/2014/main" xmlns="" id="{CB4D5C18-839D-472B-9E3F-667415484BD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96726" y="3253278"/>
            <a:ext cx="2150725" cy="1613044"/>
          </a:xfrm>
          <a:prstGeom prst="rect">
            <a:avLst/>
          </a:prstGeom>
        </p:spPr>
      </p:pic>
      <p:pic>
        <p:nvPicPr>
          <p:cNvPr id="10" name="תמונה 9" descr="תמונה שמכילה טבע, גשם&#10;&#10;התיאור נוצר באופן אוטומטי">
            <a:extLst>
              <a:ext uri="{FF2B5EF4-FFF2-40B4-BE49-F238E27FC236}">
                <a16:creationId xmlns:a16="http://schemas.microsoft.com/office/drawing/2014/main" xmlns="" id="{2551089D-A876-483C-864F-A3BB71E6A81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91530" y="5040976"/>
            <a:ext cx="2150725" cy="1613044"/>
          </a:xfrm>
          <a:prstGeom prst="rect">
            <a:avLst/>
          </a:prstGeom>
        </p:spPr>
      </p:pic>
      <p:pic>
        <p:nvPicPr>
          <p:cNvPr id="11" name="תמונה 10" descr="תמונה שמכילה גשם, טבע, קבוצה&#10;&#10;התיאור נוצר באופן אוטומטי">
            <a:extLst>
              <a:ext uri="{FF2B5EF4-FFF2-40B4-BE49-F238E27FC236}">
                <a16:creationId xmlns:a16="http://schemas.microsoft.com/office/drawing/2014/main" xmlns="" id="{59918D4E-AC87-4D01-BB69-0BFC5FAD892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7118" y="1465580"/>
            <a:ext cx="2150725" cy="1613044"/>
          </a:xfrm>
          <a:prstGeom prst="rect">
            <a:avLst/>
          </a:prstGeom>
        </p:spPr>
      </p:pic>
      <p:sp>
        <p:nvSpPr>
          <p:cNvPr id="12" name="תיבת טקסט 11">
            <a:extLst>
              <a:ext uri="{FF2B5EF4-FFF2-40B4-BE49-F238E27FC236}">
                <a16:creationId xmlns:a16="http://schemas.microsoft.com/office/drawing/2014/main" xmlns="" id="{803EF619-16FF-4CFA-AFC7-730DDA46FB8D}"/>
              </a:ext>
            </a:extLst>
          </p:cNvPr>
          <p:cNvSpPr txBox="1"/>
          <p:nvPr/>
        </p:nvSpPr>
        <p:spPr>
          <a:xfrm>
            <a:off x="119242" y="1137811"/>
            <a:ext cx="232647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dirty="0"/>
              <a:t>Library</a:t>
            </a:r>
            <a:endParaRPr lang="he-IL" dirty="0"/>
          </a:p>
        </p:txBody>
      </p:sp>
      <p:sp>
        <p:nvSpPr>
          <p:cNvPr id="13" name="תיבת טקסט 12">
            <a:extLst>
              <a:ext uri="{FF2B5EF4-FFF2-40B4-BE49-F238E27FC236}">
                <a16:creationId xmlns:a16="http://schemas.microsoft.com/office/drawing/2014/main" xmlns="" id="{B37B7F68-8FBC-452B-AFA9-5221BCF36C3A}"/>
              </a:ext>
            </a:extLst>
          </p:cNvPr>
          <p:cNvSpPr txBox="1"/>
          <p:nvPr/>
        </p:nvSpPr>
        <p:spPr>
          <a:xfrm>
            <a:off x="2533593" y="1137811"/>
            <a:ext cx="232647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dirty="0"/>
              <a:t>Control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xmlns="" val="2446144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74</TotalTime>
  <Words>73</Words>
  <Application>Microsoft Macintosh PowerPoint</Application>
  <PresentationFormat>A4 Paper (210x297 mm)</PresentationFormat>
  <Paragraphs>4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npgrjuser14</cp:lastModifiedBy>
  <cp:revision>140</cp:revision>
  <dcterms:created xsi:type="dcterms:W3CDTF">2021-06-06T09:30:00Z</dcterms:created>
  <dcterms:modified xsi:type="dcterms:W3CDTF">2021-09-22T07:12:32Z</dcterms:modified>
</cp:coreProperties>
</file>